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5" r:id="rId2"/>
  </p:sldIdLst>
  <p:sldSz cx="7559675" cy="9936163"/>
  <p:notesSz cx="6802438" cy="99345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583" userDrawn="1">
          <p15:clr>
            <a:srgbClr val="A4A3A4"/>
          </p15:clr>
        </p15:guide>
        <p15:guide id="3" orient="horz" pos="4286" userDrawn="1">
          <p15:clr>
            <a:srgbClr val="A4A3A4"/>
          </p15:clr>
        </p15:guide>
        <p15:guide id="4" orient="horz" pos="5692" userDrawn="1">
          <p15:clr>
            <a:srgbClr val="A4A3A4"/>
          </p15:clr>
        </p15:guide>
        <p15:guide id="5" orient="horz" pos="930" userDrawn="1">
          <p15:clr>
            <a:srgbClr val="A4A3A4"/>
          </p15:clr>
        </p15:guide>
        <p15:guide id="7" orient="horz" pos="3515" userDrawn="1">
          <p15:clr>
            <a:srgbClr val="A4A3A4"/>
          </p15:clr>
        </p15:guide>
        <p15:guide id="8" orient="horz" pos="2608" userDrawn="1">
          <p15:clr>
            <a:srgbClr val="A4A3A4"/>
          </p15:clr>
        </p15:guide>
        <p15:guide id="9" orient="horz" pos="4649" userDrawn="1">
          <p15:clr>
            <a:srgbClr val="A4A3A4"/>
          </p15:clr>
        </p15:guide>
        <p15:guide id="11" orient="horz" pos="4762" userDrawn="1">
          <p15:clr>
            <a:srgbClr val="A4A3A4"/>
          </p15:clr>
        </p15:guide>
        <p15:guide id="12" pos="467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腫瘍内科 近畿大学医学部" initials="腫近" lastIdx="1" clrIdx="0">
    <p:extLst>
      <p:ext uri="{19B8F6BF-5375-455C-9EA6-DF929625EA0E}">
        <p15:presenceInfo xmlns:p15="http://schemas.microsoft.com/office/powerpoint/2012/main" userId="b406ef13a87962d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82B4C"/>
    <a:srgbClr val="CCECFF"/>
    <a:srgbClr val="61FF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8D230F3-CF80-4859-8CE7-A43EE81993B5}" styleName="淡色スタイル 1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E8B1032C-EA38-4F05-BA0D-38AFFFC7BED3}" styleName="淡色スタイル 3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0660B408-B3CF-4A94-85FC-2B1E0A45F4A2}" styleName="濃色スタイル 2 - アクセント 1/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スタイル (濃色)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27"/>
  </p:normalViewPr>
  <p:slideViewPr>
    <p:cSldViewPr snapToGrid="0" snapToObjects="1" showGuides="1">
      <p:cViewPr varScale="1">
        <p:scale>
          <a:sx n="79" d="100"/>
          <a:sy n="79" d="100"/>
        </p:scale>
        <p:origin x="2970" y="96"/>
      </p:cViewPr>
      <p:guideLst>
        <p:guide pos="3583"/>
        <p:guide orient="horz" pos="4286"/>
        <p:guide orient="horz" pos="5692"/>
        <p:guide orient="horz" pos="930"/>
        <p:guide orient="horz" pos="3515"/>
        <p:guide orient="horz" pos="2608"/>
        <p:guide orient="horz" pos="4649"/>
        <p:guide orient="horz" pos="4762"/>
        <p:guide pos="467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3342" y="1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/>
          <a:lstStyle>
            <a:lvl1pPr algn="r">
              <a:defRPr sz="1200"/>
            </a:lvl1pPr>
          </a:lstStyle>
          <a:p>
            <a:fld id="{6F465158-8CF6-4271-801C-4DF7DC969FD4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27250" y="1243013"/>
            <a:ext cx="2547938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4" tIns="45688" rIns="91374" bIns="4568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562" y="4780846"/>
            <a:ext cx="5441316" cy="3911312"/>
          </a:xfrm>
          <a:prstGeom prst="rect">
            <a:avLst/>
          </a:prstGeom>
        </p:spPr>
        <p:txBody>
          <a:bodyPr vert="horz" lIns="91374" tIns="45688" rIns="91374" bIns="4568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3342" y="9436340"/>
            <a:ext cx="2947512" cy="498236"/>
          </a:xfrm>
          <a:prstGeom prst="rect">
            <a:avLst/>
          </a:prstGeom>
        </p:spPr>
        <p:txBody>
          <a:bodyPr vert="horz" lIns="91374" tIns="45688" rIns="91374" bIns="45688" rtlCol="0" anchor="b"/>
          <a:lstStyle>
            <a:lvl1pPr algn="r">
              <a:defRPr sz="1200"/>
            </a:lvl1pPr>
          </a:lstStyle>
          <a:p>
            <a:fld id="{2D556CFF-E290-41EC-82C8-7E6D0EEA4F6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4346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626127"/>
            <a:ext cx="6425724" cy="345925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218786"/>
            <a:ext cx="5669756" cy="239893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5733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5257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29009"/>
            <a:ext cx="1630055" cy="842043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29009"/>
            <a:ext cx="4795669" cy="842043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8801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13790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77144"/>
            <a:ext cx="6520220" cy="4133167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649412"/>
            <a:ext cx="6520220" cy="2173535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0418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645043"/>
            <a:ext cx="3212862" cy="63044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01299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29011"/>
            <a:ext cx="6520220" cy="192053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435741"/>
            <a:ext cx="3198096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629460"/>
            <a:ext cx="3198096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435741"/>
            <a:ext cx="3213847" cy="119371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629460"/>
            <a:ext cx="3213847" cy="53383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3883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13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1377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430626"/>
            <a:ext cx="3827085" cy="7061116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8418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62411"/>
            <a:ext cx="2438192" cy="2318438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430626"/>
            <a:ext cx="3827085" cy="7061116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80849"/>
            <a:ext cx="2438192" cy="552239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7762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29011"/>
            <a:ext cx="6520220" cy="19205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645043"/>
            <a:ext cx="6520220" cy="63044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9674DC-7F97-EF47-BEF5-67740BCEC122}" type="datetimeFigureOut">
              <a:rPr kumimoji="1" lang="ja-JP" altLang="en-US" smtClean="0"/>
              <a:t>2024/12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209353"/>
            <a:ext cx="2551390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209353"/>
            <a:ext cx="1700927" cy="52900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3CD4BE-3091-9E43-B356-910C8FFB47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6605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E4ECDDE-94EC-EE94-D29A-FB8116772EE8}"/>
              </a:ext>
            </a:extLst>
          </p:cNvPr>
          <p:cNvSpPr txBox="1"/>
          <p:nvPr/>
        </p:nvSpPr>
        <p:spPr>
          <a:xfrm>
            <a:off x="145268" y="118393"/>
            <a:ext cx="6832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  <a:endParaRPr lang="ja-JP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6DC0E11-7A38-E418-F33B-CCFA1B3C54E0}"/>
              </a:ext>
            </a:extLst>
          </p:cNvPr>
          <p:cNvSpPr txBox="1"/>
          <p:nvPr/>
        </p:nvSpPr>
        <p:spPr>
          <a:xfrm>
            <a:off x="3876995" y="7929729"/>
            <a:ext cx="8082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Patients ID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463573D8-1B74-D40B-D31D-2339D38EBB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4387" y="7912916"/>
            <a:ext cx="816935" cy="566977"/>
          </a:xfrm>
          <a:prstGeom prst="rect">
            <a:avLst/>
          </a:prstGeom>
        </p:spPr>
      </p:pic>
      <p:graphicFrame>
        <p:nvGraphicFramePr>
          <p:cNvPr id="3" name="オブジェクト 2">
            <a:extLst>
              <a:ext uri="{FF2B5EF4-FFF2-40B4-BE49-F238E27FC236}">
                <a16:creationId xmlns:a16="http://schemas.microsoft.com/office/drawing/2014/main" id="{978537B3-3DA3-87F4-53D2-B5B4C2D055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7814948"/>
              </p:ext>
            </p:extLst>
          </p:nvPr>
        </p:nvGraphicFramePr>
        <p:xfrm>
          <a:off x="552414" y="186733"/>
          <a:ext cx="6089621" cy="77532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r:id="rId3" imgW="7496345" imgH="9543973" progId="Excel.Sheet.12">
                  <p:embed/>
                </p:oleObj>
              </mc:Choice>
              <mc:Fallback>
                <p:oleObj name="Worksheet" r:id="rId3" imgW="7496345" imgH="9543973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2414" y="186733"/>
                        <a:ext cx="6089621" cy="77532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8F9F3B3-B515-7DC6-7251-26D9D186195D}"/>
              </a:ext>
            </a:extLst>
          </p:cNvPr>
          <p:cNvSpPr txBox="1"/>
          <p:nvPr/>
        </p:nvSpPr>
        <p:spPr>
          <a:xfrm>
            <a:off x="377030" y="8635909"/>
            <a:ext cx="6805613" cy="6647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Figure S4. A heat map sorted by CIN z-score of hallmark-based gene signatures observed in the pretreatment sample in EGFR-muta</a:t>
            </a: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ed</a:t>
            </a:r>
            <a:r>
              <a:rPr lang="en-US" altLang="ja-JP" sz="1000" b="1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non-small-cell lung cancer</a:t>
            </a:r>
            <a:r>
              <a:rPr lang="en-US" altLang="ja-JP" sz="1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IN, chromosomal instability; r, </a:t>
            </a:r>
            <a:r>
              <a:rPr lang="en-US" altLang="ja-JP" sz="1000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P</a:t>
            </a:r>
            <a:r>
              <a:rPr lang="en-US" altLang="ja-JP" sz="10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earson correlation coefficient.</a:t>
            </a:r>
            <a:endParaRPr lang="ja-JP" altLang="ja-JP" sz="10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2417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20</TotalTime>
  <Words>41</Words>
  <Application>Microsoft Office PowerPoint</Application>
  <PresentationFormat>ユーザー設定</PresentationFormat>
  <Paragraphs>3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游ゴシック</vt:lpstr>
      <vt:lpstr>游明朝</vt:lpstr>
      <vt:lpstr>Arial</vt:lpstr>
      <vt:lpstr>Calibri</vt:lpstr>
      <vt:lpstr>Calibri Light</vt:lpstr>
      <vt:lpstr>Times New Roman</vt:lpstr>
      <vt:lpstr>Office テーマ</vt:lpstr>
      <vt:lpstr>Worksheet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鈴木慎一郎</dc:creator>
  <cp:lastModifiedBy>仁雄 米阪</cp:lastModifiedBy>
  <cp:revision>630</cp:revision>
  <cp:lastPrinted>2024-06-06T11:43:21Z</cp:lastPrinted>
  <dcterms:created xsi:type="dcterms:W3CDTF">2021-02-12T07:53:00Z</dcterms:created>
  <dcterms:modified xsi:type="dcterms:W3CDTF">2024-12-16T00:44:59Z</dcterms:modified>
</cp:coreProperties>
</file>